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520DCCF-110F-8F01-E0C1-3DF43F71A08C}"/>
              </a:ext>
            </a:extLst>
          </p:cNvPr>
          <p:cNvSpPr txBox="1"/>
          <p:nvPr/>
        </p:nvSpPr>
        <p:spPr>
          <a:xfrm>
            <a:off x="152400" y="282417"/>
            <a:ext cx="8762999" cy="52322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general Iranian adult population working in 20 schools was invited to the study (n=600)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Validated questionnaires on lifestyle, demographic, anthropometric factors, dietary habits and intakes were distributed]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32171D16-6CA7-7DDB-32BC-1F79FD8C8D3D}"/>
              </a:ext>
            </a:extLst>
          </p:cNvPr>
          <p:cNvCxnSpPr>
            <a:cxnSpLocks/>
          </p:cNvCxnSpPr>
          <p:nvPr/>
        </p:nvCxnSpPr>
        <p:spPr>
          <a:xfrm>
            <a:off x="3429000" y="802086"/>
            <a:ext cx="0" cy="187132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82B3DF7E-6699-C300-F175-4811A2C0DC48}"/>
              </a:ext>
            </a:extLst>
          </p:cNvPr>
          <p:cNvSpPr txBox="1"/>
          <p:nvPr/>
        </p:nvSpPr>
        <p:spPr>
          <a:xfrm>
            <a:off x="1877065" y="2673406"/>
            <a:ext cx="3837936" cy="52322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ted and returned questionnaires (n=543)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sponse rate: 91.5%)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275DE000-236A-3AF7-2B71-6191AFD08388}"/>
              </a:ext>
            </a:extLst>
          </p:cNvPr>
          <p:cNvCxnSpPr>
            <a:cxnSpLocks/>
          </p:cNvCxnSpPr>
          <p:nvPr/>
        </p:nvCxnSpPr>
        <p:spPr>
          <a:xfrm>
            <a:off x="3429000" y="3217091"/>
            <a:ext cx="0" cy="223376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D301114D-8919-9793-E576-9AA512C41580}"/>
              </a:ext>
            </a:extLst>
          </p:cNvPr>
          <p:cNvSpPr txBox="1"/>
          <p:nvPr/>
        </p:nvSpPr>
        <p:spPr>
          <a:xfrm>
            <a:off x="2057401" y="5450860"/>
            <a:ext cx="3657600" cy="52322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al data included in the present analysis (n=535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1A205D-CE9D-5A89-6E17-D1E6701632E2}"/>
              </a:ext>
            </a:extLst>
          </p:cNvPr>
          <p:cNvSpPr txBox="1"/>
          <p:nvPr/>
        </p:nvSpPr>
        <p:spPr>
          <a:xfrm>
            <a:off x="4857750" y="3327654"/>
            <a:ext cx="3990337" cy="138499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ded (n= 8), due to: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orted a total energy intake outside the range of 800-4200 kcal/day.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d left more than 70 items blank on the food frequency questionnaire.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d not accept blood draw. 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14E2257F-E5A3-B7AF-F4B3-CFAD15FFA09B}"/>
              </a:ext>
            </a:extLst>
          </p:cNvPr>
          <p:cNvCxnSpPr>
            <a:cxnSpLocks/>
          </p:cNvCxnSpPr>
          <p:nvPr/>
        </p:nvCxnSpPr>
        <p:spPr>
          <a:xfrm>
            <a:off x="3429000" y="3929837"/>
            <a:ext cx="1428750" cy="1978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1FE5712-EE0D-87DA-90E2-A637993DB836}"/>
              </a:ext>
            </a:extLst>
          </p:cNvPr>
          <p:cNvSpPr txBox="1"/>
          <p:nvPr/>
        </p:nvSpPr>
        <p:spPr>
          <a:xfrm>
            <a:off x="4648200" y="976370"/>
            <a:ext cx="4267200" cy="138499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included (n=57), due to:</a:t>
            </a:r>
          </a:p>
          <a:p>
            <a:pPr>
              <a:buFont typeface="Arial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Refusing to participate in the study.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ing pregnant or breastfeeding.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ving a history of type 1 diabetes, CVD, stroke, or cancer.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hering to a wight-loss or weight-gain diet. 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3020AE6D-7A96-BCDA-BBC6-8CEEC8B1A3A4}"/>
              </a:ext>
            </a:extLst>
          </p:cNvPr>
          <p:cNvCxnSpPr>
            <a:cxnSpLocks/>
          </p:cNvCxnSpPr>
          <p:nvPr/>
        </p:nvCxnSpPr>
        <p:spPr>
          <a:xfrm>
            <a:off x="3429000" y="1491672"/>
            <a:ext cx="12192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680EFCB2-791A-7ADF-2CB1-6FE89E703A69}"/>
              </a:ext>
            </a:extLst>
          </p:cNvPr>
          <p:cNvSpPr txBox="1"/>
          <p:nvPr/>
        </p:nvSpPr>
        <p:spPr>
          <a:xfrm>
            <a:off x="533400" y="6267806"/>
            <a:ext cx="482853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hart of study participants. </a:t>
            </a:r>
          </a:p>
        </p:txBody>
      </p:sp>
    </p:spTree>
    <p:extLst>
      <p:ext uri="{BB962C8B-B14F-4D97-AF65-F5344CB8AC3E}">
        <p14:creationId xmlns:p14="http://schemas.microsoft.com/office/powerpoint/2010/main" val="1179256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9</TotalTime>
  <Words>162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hrbod</dc:creator>
  <cp:lastModifiedBy>Paris a</cp:lastModifiedBy>
  <cp:revision>22</cp:revision>
  <dcterms:created xsi:type="dcterms:W3CDTF">2006-08-16T00:00:00Z</dcterms:created>
  <dcterms:modified xsi:type="dcterms:W3CDTF">2023-08-17T12:43:59Z</dcterms:modified>
</cp:coreProperties>
</file>